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04DD1-A8F2-4EAF-BE4B-2E8A5FAD6F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F6475-CC59-48E2-86B8-68D4C665E4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5D5D7-89CD-4118-9686-BB9ADABAF82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C1F6D0-CCBF-4B27-B7ED-BA0B473FD2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4BB84-EFAC-4D49-9FC9-C553DFAA0A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CDBFE-81C3-480F-82E6-1C7D75DC44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F5CC5-36F3-411F-86AA-3C26A29781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8DCA5-2C8D-441D-B3D8-41634CEC3E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4C4E2-D971-48F6-BDBC-E16A589891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AA3E8-BCF6-4C7A-97B0-2189623F92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988B0-95B8-4A74-B081-D33DA39107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1CFAE-A9A5-46D1-9341-62FBD9C0C5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F3FA63-FD9F-4707-B0A0-E3BAF468EDBE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4"/>
          <p:cNvSpPr/>
          <p:nvPr/>
        </p:nvSpPr>
        <p:spPr>
          <a:xfrm>
            <a:off x="1625760" y="1146240"/>
            <a:ext cx="2612880" cy="8348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freshes my memor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" name="矩形 5"/>
          <p:cNvSpPr/>
          <p:nvPr/>
        </p:nvSpPr>
        <p:spPr>
          <a:xfrm>
            <a:off x="1625760" y="2470320"/>
            <a:ext cx="2612880" cy="8334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proval by emergency physician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" name="矩形 6"/>
          <p:cNvSpPr/>
          <p:nvPr/>
        </p:nvSpPr>
        <p:spPr>
          <a:xfrm>
            <a:off x="1625760" y="3794040"/>
            <a:ext cx="2612880" cy="835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duces intervention error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" name="矩形 7"/>
          <p:cNvSpPr/>
          <p:nvPr/>
        </p:nvSpPr>
        <p:spPr>
          <a:xfrm>
            <a:off x="1625760" y="5157720"/>
            <a:ext cx="2612880" cy="835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proval by patient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5" name="矩形 8"/>
          <p:cNvSpPr/>
          <p:nvPr/>
        </p:nvSpPr>
        <p:spPr>
          <a:xfrm>
            <a:off x="7953480" y="2882880"/>
            <a:ext cx="2401920" cy="12049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ten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cxnSp>
        <p:nvCxnSpPr>
          <p:cNvPr id="46" name="直接箭头连接符 9"/>
          <p:cNvCxnSpPr>
            <a:stCxn id="41" idx="3"/>
          </p:cNvCxnSpPr>
          <p:nvPr/>
        </p:nvCxnSpPr>
        <p:spPr>
          <a:xfrm>
            <a:off x="4238640" y="1563480"/>
            <a:ext cx="3715200" cy="17024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7" name="直接箭头连接符 12"/>
          <p:cNvCxnSpPr/>
          <p:nvPr/>
        </p:nvCxnSpPr>
        <p:spPr>
          <a:xfrm>
            <a:off x="4223880" y="2885760"/>
            <a:ext cx="3729960" cy="5259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8" name="直接箭头连接符 16"/>
          <p:cNvCxnSpPr>
            <a:stCxn id="43" idx="3"/>
          </p:cNvCxnSpPr>
          <p:nvPr/>
        </p:nvCxnSpPr>
        <p:spPr>
          <a:xfrm flipV="1">
            <a:off x="4238640" y="3720240"/>
            <a:ext cx="3715200" cy="4917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9" name="直接箭头连接符 20"/>
          <p:cNvCxnSpPr>
            <a:stCxn id="44" idx="3"/>
          </p:cNvCxnSpPr>
          <p:nvPr/>
        </p:nvCxnSpPr>
        <p:spPr>
          <a:xfrm flipV="1">
            <a:off x="4238640" y="3872880"/>
            <a:ext cx="3715200" cy="17028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0" name="文本框 23"/>
          <p:cNvSpPr/>
          <p:nvPr/>
        </p:nvSpPr>
        <p:spPr>
          <a:xfrm rot="1443000">
            <a:off x="4633920" y="1706400"/>
            <a:ext cx="182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=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43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&lt; .0001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1" name="文本框 24"/>
          <p:cNvSpPr/>
          <p:nvPr/>
        </p:nvSpPr>
        <p:spPr>
          <a:xfrm rot="574800">
            <a:off x="4527720" y="2665080"/>
            <a:ext cx="1938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=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27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&lt; .0001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2" name="文本框 25"/>
          <p:cNvSpPr/>
          <p:nvPr/>
        </p:nvSpPr>
        <p:spPr>
          <a:xfrm rot="21199200">
            <a:off x="4542480" y="3649320"/>
            <a:ext cx="167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=.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1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&lt; .009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3" name="文本框 26"/>
          <p:cNvSpPr/>
          <p:nvPr/>
        </p:nvSpPr>
        <p:spPr>
          <a:xfrm rot="20137200">
            <a:off x="4647960" y="4538160"/>
            <a:ext cx="179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=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19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&lt; .0001)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4" name="TextBox 1"/>
          <p:cNvSpPr/>
          <p:nvPr/>
        </p:nvSpPr>
        <p:spPr>
          <a:xfrm>
            <a:off x="1031760" y="384120"/>
            <a:ext cx="9783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mergency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ysicians’salient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elief analysis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6T02:02:54Z</dcterms:created>
  <dc:creator>Lenovo</dc:creator>
  <dc:description/>
  <dc:language>en-US</dc:language>
  <cp:lastModifiedBy>Said Abasse Kassim</cp:lastModifiedBy>
  <dcterms:modified xsi:type="dcterms:W3CDTF">2021-05-24T14:15:12Z</dcterms:modified>
  <cp:revision>44</cp:revision>
  <dc:subject/>
  <dc:title>PowerPoint 演示文稿</dc:title>
</cp:coreProperties>
</file>